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9"/>
    <p:restoredTop sz="94659"/>
  </p:normalViewPr>
  <p:slideViewPr>
    <p:cSldViewPr snapToGrid="0" snapToObjects="1">
      <p:cViewPr>
        <p:scale>
          <a:sx n="158" d="100"/>
          <a:sy n="158" d="100"/>
        </p:scale>
        <p:origin x="92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5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981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691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148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938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031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934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43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28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585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636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48314A-4897-914F-9845-6EAE5EF5B9B5}" type="datetimeFigureOut">
              <a:rPr lang="en-US" smtClean="0"/>
              <a:t>4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559C2-B5D7-9645-B20E-965923FC61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56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7BDC7B93-D85C-394F-B0DE-132394FD16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492" y="2038954"/>
            <a:ext cx="1948339" cy="1851660"/>
          </a:xfrm>
          <a:prstGeom prst="rect">
            <a:avLst/>
          </a:prstGeom>
          <a:noFill/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B352A728-9FF8-C945-92D3-3C974CA8720C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9555" y="2038954"/>
            <a:ext cx="2040503" cy="1893839"/>
          </a:xfrm>
          <a:prstGeom prst="rect">
            <a:avLst/>
          </a:prstGeom>
          <a:noFill/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AB7CD781-494E-AB48-9214-0A7A4231DC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776" y="379904"/>
            <a:ext cx="2011177" cy="1811474"/>
          </a:xfrm>
          <a:prstGeom prst="rect">
            <a:avLst/>
          </a:prstGeom>
          <a:noFill/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A155855-186F-7D48-B293-1D92808F93C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780" y="3850428"/>
            <a:ext cx="1948339" cy="1851660"/>
          </a:xfrm>
          <a:prstGeom prst="rect">
            <a:avLst/>
          </a:prstGeom>
          <a:noFill/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7AD1D9F5-A203-B648-A3D0-26806FE642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54831" y="461968"/>
            <a:ext cx="1571625" cy="14859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C1BB0CDD-8FBD-764E-82CB-D7EE3906951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93010" y="471209"/>
            <a:ext cx="1571625" cy="14859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97E763DF-643B-2B44-9576-02D0021127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94227" y="2152185"/>
            <a:ext cx="1666736" cy="162519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9E3DAB2-A597-524F-B81F-06C882515C01}"/>
              </a:ext>
            </a:extLst>
          </p:cNvPr>
          <p:cNvSpPr txBox="1"/>
          <p:nvPr/>
        </p:nvSpPr>
        <p:spPr>
          <a:xfrm>
            <a:off x="2447152" y="1533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4092E424-0324-094D-82DC-206FBACB9483}"/>
              </a:ext>
            </a:extLst>
          </p:cNvPr>
          <p:cNvSpPr txBox="1"/>
          <p:nvPr/>
        </p:nvSpPr>
        <p:spPr>
          <a:xfrm>
            <a:off x="550572" y="1719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B5801C4-3B32-AF48-BB1D-238454BA06BC}"/>
              </a:ext>
            </a:extLst>
          </p:cNvPr>
          <p:cNvSpPr txBox="1"/>
          <p:nvPr/>
        </p:nvSpPr>
        <p:spPr>
          <a:xfrm>
            <a:off x="4277765" y="1952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8A23860-9DD9-E048-AA48-770FEF3C8FA5}"/>
              </a:ext>
            </a:extLst>
          </p:cNvPr>
          <p:cNvSpPr txBox="1"/>
          <p:nvPr/>
        </p:nvSpPr>
        <p:spPr>
          <a:xfrm>
            <a:off x="517263" y="189244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EC29868-0A61-914C-951B-B78C193ACB73}"/>
              </a:ext>
            </a:extLst>
          </p:cNvPr>
          <p:cNvSpPr txBox="1"/>
          <p:nvPr/>
        </p:nvSpPr>
        <p:spPr>
          <a:xfrm>
            <a:off x="2356482" y="188970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9401A717-74B5-CA4D-B0F4-5A714B604C64}"/>
              </a:ext>
            </a:extLst>
          </p:cNvPr>
          <p:cNvSpPr txBox="1"/>
          <p:nvPr/>
        </p:nvSpPr>
        <p:spPr>
          <a:xfrm>
            <a:off x="4279631" y="185428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786264BE-3ADD-034A-8B87-CCB9946F0659}"/>
              </a:ext>
            </a:extLst>
          </p:cNvPr>
          <p:cNvSpPr txBox="1"/>
          <p:nvPr/>
        </p:nvSpPr>
        <p:spPr>
          <a:xfrm>
            <a:off x="550572" y="3723556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7A8A69D4-8320-084B-BE4A-3CD9C904A4A9}"/>
              </a:ext>
            </a:extLst>
          </p:cNvPr>
          <p:cNvSpPr txBox="1"/>
          <p:nvPr/>
        </p:nvSpPr>
        <p:spPr>
          <a:xfrm>
            <a:off x="457191" y="6244302"/>
            <a:ext cx="580674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ating strategy for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ain samples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brain sampl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AERO-infected rat at 7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pi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ral gat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rateg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egins with (A) vital brain gate, (B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ive/dea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ting and (C) singlet inclusion. Myeloid cells were gated as follows:  (D) Peripheral macrophages as CD163+, (E) neutrophils as RP-1+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, and (F) microglia as Iba-1+. (G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ba1+ microgli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n b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urther characterized based on level of CD45 express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-cells were gated as (H) CD3+ and then categorized as either (I) CD8+ or CD4+.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D1AF1C52-1CD8-F645-992D-8AB2C269CF8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862" t="6806" r="9094" b="7621"/>
          <a:stretch/>
        </p:blipFill>
        <p:spPr>
          <a:xfrm>
            <a:off x="2051751" y="3972460"/>
            <a:ext cx="1841259" cy="167276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B480C13E-C092-2044-B613-948C4281ABD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181" t="7181" r="10274" b="7132"/>
          <a:stretch/>
        </p:blipFill>
        <p:spPr>
          <a:xfrm>
            <a:off x="3827391" y="3983780"/>
            <a:ext cx="1944829" cy="180136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123FE2B-782E-2944-B733-4C99CFC5F966}"/>
              </a:ext>
            </a:extLst>
          </p:cNvPr>
          <p:cNvSpPr txBox="1"/>
          <p:nvPr/>
        </p:nvSpPr>
        <p:spPr>
          <a:xfrm>
            <a:off x="2298286" y="37349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034DFF34-5F3C-3142-909B-139F30309659}"/>
              </a:ext>
            </a:extLst>
          </p:cNvPr>
          <p:cNvSpPr txBox="1"/>
          <p:nvPr/>
        </p:nvSpPr>
        <p:spPr>
          <a:xfrm>
            <a:off x="4105615" y="3735039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420865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123</Words>
  <Application>Microsoft Macintosh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, Joseph R</dc:creator>
  <cp:lastModifiedBy>Hartman, Amy Lynn</cp:lastModifiedBy>
  <cp:revision>14</cp:revision>
  <cp:lastPrinted>2019-01-10T21:19:03Z</cp:lastPrinted>
  <dcterms:created xsi:type="dcterms:W3CDTF">2019-01-10T18:51:42Z</dcterms:created>
  <dcterms:modified xsi:type="dcterms:W3CDTF">2019-04-20T00:42:48Z</dcterms:modified>
</cp:coreProperties>
</file>